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6FF"/>
    <a:srgbClr val="00918C"/>
    <a:srgbClr val="F7FE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2716C2E-9236-4FFA-8AE2-B57995540330}" v="6" dt="2021-09-15T16:45:23.5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64" autoAdjust="0"/>
    <p:restoredTop sz="94656"/>
  </p:normalViewPr>
  <p:slideViewPr>
    <p:cSldViewPr snapToGrid="0">
      <p:cViewPr>
        <p:scale>
          <a:sx n="93" d="100"/>
          <a:sy n="93" d="100"/>
        </p:scale>
        <p:origin x="1272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09990776241389"/>
          <c:y val="0.12163904924078361"/>
          <c:w val="0.75468697435605858"/>
          <c:h val="0.58994823749489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ot Assesabl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Post-Intervention
 (N = 100)</c:v>
                </c:pt>
                <c:pt idx="1">
                  <c:v>Pre-Intervention
(N = 100)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4D-45DE-B7DE-875EE054374C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adequate</c:v>
                </c:pt>
              </c:strCache>
            </c:strRef>
          </c:tx>
          <c:spPr>
            <a:solidFill>
              <a:srgbClr val="FF6565"/>
            </a:solidFill>
            <a:ln w="12700">
              <a:solidFill>
                <a:srgbClr val="DB3142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ost-Intervention
 (N = 100)</c:v>
                </c:pt>
                <c:pt idx="1">
                  <c:v>Pre-Intervention
(N = 100)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12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E4D-45DE-B7DE-875EE054374C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Suboptimal</c:v>
                </c:pt>
              </c:strCache>
            </c:strRef>
          </c:tx>
          <c:spPr>
            <a:solidFill>
              <a:srgbClr val="F8B177"/>
            </a:solidFill>
            <a:ln w="12700">
              <a:solidFill>
                <a:srgbClr val="DB3142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ost-Intervention
 (N = 100)</c:v>
                </c:pt>
                <c:pt idx="1">
                  <c:v>Pre-Intervention
(N = 100)</c:v>
                </c:pt>
              </c:strCache>
            </c:strRef>
          </c:cat>
          <c:val>
            <c:numRef>
              <c:f>Sheet1!$D$2:$D$3</c:f>
              <c:numCache>
                <c:formatCode>General</c:formatCode>
                <c:ptCount val="2"/>
                <c:pt idx="0">
                  <c:v>26</c:v>
                </c:pt>
                <c:pt idx="1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E4D-45DE-B7DE-875EE054374C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Adequate</c:v>
                </c:pt>
              </c:strCache>
            </c:strRef>
          </c:tx>
          <c:spPr>
            <a:solidFill>
              <a:srgbClr val="CFE393"/>
            </a:solidFill>
            <a:ln w="12700">
              <a:solidFill>
                <a:srgbClr val="00918C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ost-Intervention
 (N = 100)</c:v>
                </c:pt>
                <c:pt idx="1">
                  <c:v>Pre-Intervention
(N = 100)</c:v>
                </c:pt>
              </c:strCache>
            </c:strRef>
          </c:cat>
          <c:val>
            <c:numRef>
              <c:f>Sheet1!$E$2:$E$3</c:f>
              <c:numCache>
                <c:formatCode>General</c:formatCode>
                <c:ptCount val="2"/>
                <c:pt idx="0">
                  <c:v>18</c:v>
                </c:pt>
                <c:pt idx="1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E4D-45DE-B7DE-875EE054374C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Optimal</c:v>
                </c:pt>
              </c:strCache>
            </c:strRef>
          </c:tx>
          <c:spPr>
            <a:solidFill>
              <a:srgbClr val="A6CF42"/>
            </a:solidFill>
            <a:ln w="12700">
              <a:solidFill>
                <a:srgbClr val="00918C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A6CF42"/>
              </a:solidFill>
              <a:ln w="12700">
                <a:solidFill>
                  <a:srgbClr val="00918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4D-45DE-B7DE-875EE054374C}"/>
              </c:ext>
            </c:extLst>
          </c:dPt>
          <c:dPt>
            <c:idx val="1"/>
            <c:invertIfNegative val="0"/>
            <c:bubble3D val="0"/>
            <c:spPr>
              <a:solidFill>
                <a:srgbClr val="A6CF42"/>
              </a:solidFill>
              <a:ln w="12700">
                <a:solidFill>
                  <a:srgbClr val="00918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E4D-45DE-B7DE-875EE054374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ost-Intervention
 (N = 100)</c:v>
                </c:pt>
                <c:pt idx="1">
                  <c:v>Pre-Intervention
(N = 100)</c:v>
                </c:pt>
              </c:strCache>
            </c:strRef>
          </c:cat>
          <c:val>
            <c:numRef>
              <c:f>Sheet1!$F$2:$F$3</c:f>
              <c:numCache>
                <c:formatCode>General</c:formatCode>
                <c:ptCount val="2"/>
                <c:pt idx="0">
                  <c:v>44</c:v>
                </c:pt>
                <c:pt idx="1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E4D-45DE-B7DE-875EE05437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100"/>
        <c:axId val="508931952"/>
        <c:axId val="519498392"/>
      </c:barChart>
      <c:catAx>
        <c:axId val="5089319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+mn-cs"/>
              </a:defRPr>
            </a:pPr>
            <a:endParaRPr lang="en-US"/>
          </a:p>
        </c:txPr>
        <c:crossAx val="519498392"/>
        <c:crosses val="autoZero"/>
        <c:auto val="1"/>
        <c:lblAlgn val="ctr"/>
        <c:lblOffset val="100"/>
        <c:noMultiLvlLbl val="0"/>
      </c:catAx>
      <c:valAx>
        <c:axId val="5194983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+mn-cs"/>
                  </a:defRPr>
                </a:pPr>
                <a:r>
                  <a:rPr lang="en-US" sz="1200">
                    <a:latin typeface="Verdana" panose="020B0604030504040204" pitchFamily="34" charset="0"/>
                    <a:ea typeface="Verdana" panose="020B0604030504040204" pitchFamily="34" charset="0"/>
                  </a:rPr>
                  <a:t>Prescriptions (%)</a:t>
                </a:r>
              </a:p>
            </c:rich>
          </c:tx>
          <c:layout>
            <c:manualLayout>
              <c:xMode val="edge"/>
              <c:yMode val="edge"/>
              <c:x val="0.50766523349441162"/>
              <c:y val="0.82125375006568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Verdana" panose="020B0604030504040204" pitchFamily="34" charset="0"/>
                  <a:ea typeface="Verdana" panose="020B0604030504040204" pitchFamily="34" charset="0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+mn-cs"/>
              </a:defRPr>
            </a:pPr>
            <a:endParaRPr lang="en-US"/>
          </a:p>
        </c:txPr>
        <c:crossAx val="50893195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16349881508913947"/>
          <c:y val="0.89788944825920292"/>
          <c:w val="0.81260554758332026"/>
          <c:h val="0.102110629126948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4339</cdr:x>
      <cdr:y>0.36382</cdr:y>
    </cdr:from>
    <cdr:to>
      <cdr:x>0.61158</cdr:x>
      <cdr:y>0.4779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200337" y="929279"/>
          <a:ext cx="1718441" cy="2915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>
              <a:latin typeface="Verdana" panose="020B0604030504040204" pitchFamily="34" charset="0"/>
              <a:ea typeface="Verdana" panose="020B0604030504040204" pitchFamily="34" charset="0"/>
            </a:rPr>
            <a:t>Inappropriate</a:t>
          </a:r>
          <a:endParaRPr lang="en-US" sz="1200" dirty="0">
            <a:latin typeface="Verdana" panose="020B0604030504040204" pitchFamily="34" charset="0"/>
            <a:ea typeface="Verdana" panose="020B060403050404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D8235-1BB9-412F-BA17-C6F762F02A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0BA6283-67E8-4982-974D-9699CDE8FD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03B7DF-A95A-42BC-A2BE-D27F036BE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62E229-59B9-475E-B25D-1CDB0AC1F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0403F3-4D7B-4235-970D-7CB8FCF14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666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389DC-56FB-4579-B2C6-E9AA75F927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1F9831-ED92-42E5-A437-42F7E375E2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359705-89FE-40B5-99FA-C438424C9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B59EE-F9C5-4506-8B4F-F8D003E2F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FD5AE-E766-4F30-95DF-EA71E8FB9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240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79242B-04B2-4707-B11C-A31C47D329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993D53-3F15-4BEC-82A2-1271747BAA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6E293F-0213-4FA2-8AF7-862A3EBA6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57E67A-29B5-4291-8C99-BAF425C3F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8D283A-31F8-426F-8229-ACE59584B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010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EA724-61E1-4632-AF23-FD1B27C12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F429AB-1E1C-4898-A6B5-EEE9784B35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5FC105-1409-4C63-8989-018F0167A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44EF65-48E8-4C94-98D5-9F66D1C0A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F2600-AAEF-4927-8E07-13DA04959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622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9E7CC-EC79-4E2E-95BE-161C1B5A3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944CD-30EB-46A5-A856-555E76A90E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D535ED-53C9-46C4-AD84-C4A01FEED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847CD7-3832-4A24-B234-E7A9AEEE6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9FB0C-62A6-4B6C-9553-88CB910E4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14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A0D29-55C5-4912-95E0-6B321C75E7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F0AFA7-B0DD-49DE-88EF-D11611C5AD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28D05D-4C81-4768-AC59-41F3F1E691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48A3D6-EE6B-4B7F-BA08-B2FD65FC4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4D35CA-10D1-49D3-ADA7-BDBF12E6A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E834F7-FD8C-4273-9086-F2EEBAC0D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212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A43370-0818-402A-A6DD-BF126629F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6BEC69-F0FB-4C06-9C4A-A5F30AEAD8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DFE8B8-533B-47C3-B832-A7F452F4F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6368C4-B282-4A7E-B315-132899FCBD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0C1D04-178C-4284-BF37-3F3133952E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BB566F-730D-412F-88DF-014164C13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3A3E42-618B-4532-BB4B-C71997430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986F32-0BFE-43AD-BE48-75FB5E946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602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448A3-0A2A-4C10-98D4-BE0DB0C44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4F4C90-9B69-4782-874B-D5E0F276B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726089-1157-49DB-868A-2F99FDE14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6ACA56-EBBE-4AED-973E-3A12BD6DD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411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B917F5-A705-4D65-B01D-8985EA73F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C2A42E-6360-41AA-8253-0D4C759A4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D8935C-9BB1-4585-88DD-028ACA0A8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879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AA1C5E-44F9-47FB-B4BE-87B3136D3C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669068-1AC2-445D-A5EB-BC96A4FAAE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B06C56-971D-4E1A-9131-E5F95FF96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4C9BF8-55F0-4BD7-835C-9AE8425AC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C42F41-A2A7-45A9-9BC6-603AC8F0A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BB2612-8ECD-4ABB-ACDF-CF2776883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010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ADD35-1AF8-4B09-BE0C-26C094A461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B0F6CF-0972-4A5E-B05E-C2814A79A5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B21FFC-050B-4B4A-BC67-5BC46A6E61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42BCBE-1AF6-4947-9607-5DF2E53F5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CE99EC-1629-4C64-95A7-9076789D9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F0BEDF-5EF0-4CE2-B9B8-3B32640FF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518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B81062-0A87-4A0A-94C9-48B19E8D39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E1A516-734B-4B77-AE8B-2C53E0C152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907254-13ED-4FA7-94D2-137BE50B32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6731F-1289-496D-82E8-4D0A9F9C9260}" type="datetimeFigureOut">
              <a:rPr lang="en-US" smtClean="0"/>
              <a:t>2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E270D3-A7E6-4804-8C69-A4275142AC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0F207-5FA7-43A1-ACDC-2077DE6140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5F130-F9F2-43BA-97B6-27DD96F8D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937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11.svg"/><Relationship Id="rId3" Type="http://schemas.openxmlformats.org/officeDocument/2006/relationships/chart" Target="../charts/chart1.xml"/><Relationship Id="rId7" Type="http://schemas.openxmlformats.org/officeDocument/2006/relationships/image" Target="../media/image5.svg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9.svg"/><Relationship Id="rId5" Type="http://schemas.openxmlformats.org/officeDocument/2006/relationships/image" Target="../media/image3.svg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openxmlformats.org/officeDocument/2006/relationships/image" Target="../media/image7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20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DFDDD54-4A52-4F81-A503-C62D49FDFE56}"/>
              </a:ext>
            </a:extLst>
          </p:cNvPr>
          <p:cNvSpPr/>
          <p:nvPr/>
        </p:nvSpPr>
        <p:spPr>
          <a:xfrm>
            <a:off x="124093" y="1293570"/>
            <a:ext cx="11879824" cy="4686641"/>
          </a:xfrm>
          <a:prstGeom prst="rect">
            <a:avLst/>
          </a:prstGeom>
          <a:solidFill>
            <a:schemeClr val="bg1"/>
          </a:solidFill>
          <a:ln w="117475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.5</a:t>
            </a:r>
          </a:p>
        </p:txBody>
      </p:sp>
      <p:sp>
        <p:nvSpPr>
          <p:cNvPr id="6" name="AutoShape 2" descr="doctor free icon">
            <a:extLst>
              <a:ext uri="{FF2B5EF4-FFF2-40B4-BE49-F238E27FC236}">
                <a16:creationId xmlns:a16="http://schemas.microsoft.com/office/drawing/2014/main" id="{674CA06A-4870-4428-99B9-5CFCB889C23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599" y="1862959"/>
            <a:ext cx="1718441" cy="17184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B93D998-D3A2-4338-88E7-FC2C5E299FF0}"/>
              </a:ext>
            </a:extLst>
          </p:cNvPr>
          <p:cNvSpPr txBox="1"/>
          <p:nvPr/>
        </p:nvSpPr>
        <p:spPr>
          <a:xfrm>
            <a:off x="1998285" y="225657"/>
            <a:ext cx="1030530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kern="0" dirty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ntimicrobial Stewardship Initiative on Prescribing at Discharge from a Community Medical Center </a:t>
            </a:r>
            <a:endParaRPr lang="en-US" sz="2800" dirty="0">
              <a:solidFill>
                <a:schemeClr val="bg1"/>
              </a:solidFill>
              <a:latin typeface="Verdana" panose="020B060403050404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7349005-7B69-40B0-9207-EB77CC330132}"/>
              </a:ext>
            </a:extLst>
          </p:cNvPr>
          <p:cNvSpPr txBox="1"/>
          <p:nvPr/>
        </p:nvSpPr>
        <p:spPr>
          <a:xfrm>
            <a:off x="155884" y="6216316"/>
            <a:ext cx="73944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enkar</a:t>
            </a:r>
            <a:r>
              <a:rPr lang="en-US" sz="2800" dirty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et al. </a:t>
            </a:r>
            <a:r>
              <a:rPr lang="en-US" sz="2800" i="1" dirty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SHE</a:t>
            </a:r>
            <a:r>
              <a:rPr lang="en-US" sz="2800" dirty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. February 2024.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B847498-F86B-48B5-BE6E-1C078ED47866}"/>
              </a:ext>
            </a:extLst>
          </p:cNvPr>
          <p:cNvSpPr txBox="1"/>
          <p:nvPr/>
        </p:nvSpPr>
        <p:spPr>
          <a:xfrm>
            <a:off x="8391439" y="6222338"/>
            <a:ext cx="36124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800" dirty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@ASHE_Journa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F116D8A-54A9-47E9-9F76-07E6770DF29D}"/>
              </a:ext>
            </a:extLst>
          </p:cNvPr>
          <p:cNvSpPr txBox="1"/>
          <p:nvPr/>
        </p:nvSpPr>
        <p:spPr>
          <a:xfrm rot="16200000">
            <a:off x="-356634" y="1882782"/>
            <a:ext cx="4682638" cy="3657600"/>
          </a:xfrm>
          <a:prstGeom prst="rect">
            <a:avLst/>
          </a:prstGeom>
          <a:noFill/>
          <a:ln w="76200"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BE6B28A-8E74-494C-A095-5119F5A825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330" y="100701"/>
            <a:ext cx="1818603" cy="1120179"/>
          </a:xfrm>
          <a:prstGeom prst="rect">
            <a:avLst/>
          </a:prstGeom>
          <a:ln w="22225">
            <a:solidFill>
              <a:schemeClr val="bg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1215499-9F91-43F6-91E0-940F55B826A8}"/>
              </a:ext>
            </a:extLst>
          </p:cNvPr>
          <p:cNvSpPr txBox="1"/>
          <p:nvPr/>
        </p:nvSpPr>
        <p:spPr>
          <a:xfrm>
            <a:off x="3813485" y="1365406"/>
            <a:ext cx="8190431" cy="1737360"/>
          </a:xfrm>
          <a:prstGeom prst="rect">
            <a:avLst/>
          </a:prstGeom>
          <a:noFill/>
          <a:ln w="76200"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8C5F3C33-39F7-EFF0-CE1B-515227093A9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73741936"/>
              </p:ext>
            </p:extLst>
          </p:nvPr>
        </p:nvGraphicFramePr>
        <p:xfrm>
          <a:off x="3910145" y="3327813"/>
          <a:ext cx="6520217" cy="25542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5" name="Straight Connector 4"/>
          <p:cNvCxnSpPr>
            <a:cxnSpLocks/>
          </p:cNvCxnSpPr>
          <p:nvPr/>
        </p:nvCxnSpPr>
        <p:spPr>
          <a:xfrm flipV="1">
            <a:off x="7380527" y="4242693"/>
            <a:ext cx="644689" cy="29955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B37363A-0968-4947-ABD6-F98F76509E8E}"/>
              </a:ext>
            </a:extLst>
          </p:cNvPr>
          <p:cNvSpPr txBox="1"/>
          <p:nvPr/>
        </p:nvSpPr>
        <p:spPr>
          <a:xfrm>
            <a:off x="2710590" y="1499842"/>
            <a:ext cx="10371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ults with </a:t>
            </a:r>
            <a:r>
              <a:rPr lang="en-US" sz="2000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Oral </a:t>
            </a:r>
            <a:r>
              <a:rPr lang="en-US" sz="2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</a:t>
            </a:r>
            <a:r>
              <a:rPr lang="en-US" sz="2000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timicrobial </a:t>
            </a:r>
            <a:r>
              <a:rPr lang="en-US" sz="2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</a:t>
            </a:r>
            <a:r>
              <a:rPr lang="en-US" sz="2000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egimen </a:t>
            </a:r>
            <a:r>
              <a:rPr lang="en-US" sz="2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t </a:t>
            </a:r>
            <a:r>
              <a:rPr lang="en-US" sz="2000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Hospital Discharge</a:t>
            </a:r>
            <a:endParaRPr lang="en-US" sz="2000" dirty="0">
              <a:latin typeface="Verdana" panose="020B060403050404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665FB89-BAEC-4531-8290-9B9ED151BAC5}"/>
              </a:ext>
            </a:extLst>
          </p:cNvPr>
          <p:cNvSpPr txBox="1"/>
          <p:nvPr/>
        </p:nvSpPr>
        <p:spPr>
          <a:xfrm>
            <a:off x="4078475" y="2136167"/>
            <a:ext cx="20134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 = 100</a:t>
            </a:r>
          </a:p>
          <a:p>
            <a:pPr algn="ctr"/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re-initiativ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665FB89-BAEC-4531-8290-9B9ED151BAC5}"/>
              </a:ext>
            </a:extLst>
          </p:cNvPr>
          <p:cNvSpPr txBox="1"/>
          <p:nvPr/>
        </p:nvSpPr>
        <p:spPr>
          <a:xfrm>
            <a:off x="9856947" y="2136167"/>
            <a:ext cx="17642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 = 100</a:t>
            </a:r>
          </a:p>
          <a:p>
            <a:pPr algn="ctr"/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ost-initiativ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398502" y="2198400"/>
            <a:ext cx="1253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versus</a:t>
            </a:r>
            <a:endParaRPr lang="en-US" sz="1600" dirty="0">
              <a:latin typeface="Verdana" panose="020B060403050404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665FB89-BAEC-4531-8290-9B9ED151BAC5}"/>
              </a:ext>
            </a:extLst>
          </p:cNvPr>
          <p:cNvSpPr txBox="1"/>
          <p:nvPr/>
        </p:nvSpPr>
        <p:spPr>
          <a:xfrm>
            <a:off x="29612" y="1501666"/>
            <a:ext cx="391014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u="sng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Quality </a:t>
            </a:r>
            <a:r>
              <a:rPr lang="en-US" sz="1500" b="1" u="sng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Improvement </a:t>
            </a:r>
            <a:r>
              <a:rPr lang="en-US" sz="1500" b="1" u="sng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I</a:t>
            </a:r>
            <a:r>
              <a:rPr lang="en-US" sz="1500" b="1" u="sng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itiative</a:t>
            </a:r>
            <a:endParaRPr lang="en-US" sz="1500" b="1" u="sng" dirty="0">
              <a:latin typeface="Verdana" panose="020B060403050404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1AFFCF1-287C-4EFF-A764-358ED4B4B902}"/>
              </a:ext>
            </a:extLst>
          </p:cNvPr>
          <p:cNvSpPr txBox="1"/>
          <p:nvPr/>
        </p:nvSpPr>
        <p:spPr>
          <a:xfrm>
            <a:off x="3443921" y="3158056"/>
            <a:ext cx="87408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APS* Antimicrobial </a:t>
            </a:r>
            <a:r>
              <a:rPr lang="en-US" sz="2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egimen Appropriatenes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50890" y="1957782"/>
            <a:ext cx="22299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</a:rPr>
              <a:t>Antimicrobial Prescribing </a:t>
            </a:r>
            <a:r>
              <a:rPr lang="en-US" dirty="0" smtClean="0">
                <a:latin typeface="Verdana" panose="020B0604030504040204" pitchFamily="34" charset="0"/>
                <a:ea typeface="Verdana" panose="020B0604030504040204" pitchFamily="34" charset="0"/>
              </a:rPr>
              <a:t>Guideline Development</a:t>
            </a:r>
            <a:endParaRPr lang="en-US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626445" y="4490434"/>
            <a:ext cx="213082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</a:rPr>
              <a:t>Pharmacist Prospective Audit and Feedback</a:t>
            </a:r>
          </a:p>
          <a:p>
            <a:pPr algn="ctr"/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1576884" y="3367466"/>
            <a:ext cx="22299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Verdana" panose="020B0604030504040204" pitchFamily="34" charset="0"/>
                <a:ea typeface="Verdana" panose="020B0604030504040204" pitchFamily="34" charset="0"/>
              </a:rPr>
              <a:t>Hospital-wide Clinician </a:t>
            </a:r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</a:rPr>
              <a:t>Education 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10381521" y="3557565"/>
            <a:ext cx="1803270" cy="2243339"/>
            <a:chOff x="10157109" y="3668778"/>
            <a:chExt cx="1803270" cy="2243339"/>
          </a:xfrm>
        </p:grpSpPr>
        <p:grpSp>
          <p:nvGrpSpPr>
            <p:cNvPr id="8" name="Group 7"/>
            <p:cNvGrpSpPr/>
            <p:nvPr/>
          </p:nvGrpSpPr>
          <p:grpSpPr>
            <a:xfrm>
              <a:off x="10192015" y="3668778"/>
              <a:ext cx="1768364" cy="1267184"/>
              <a:chOff x="10287972" y="3687034"/>
              <a:chExt cx="1768364" cy="1267184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EA6E6A3B-8EB1-DDBF-B208-15E986A7219D}"/>
                  </a:ext>
                </a:extLst>
              </p:cNvPr>
              <p:cNvSpPr/>
              <p:nvPr/>
            </p:nvSpPr>
            <p:spPr>
              <a:xfrm>
                <a:off x="10306635" y="4086288"/>
                <a:ext cx="1749701" cy="86793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90000"/>
                  </a:lnSpc>
                </a:pPr>
                <a:r>
                  <a:rPr lang="en-US" altLang="en-US" sz="1400" dirty="0" smtClean="0"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in overall </a:t>
                </a:r>
                <a:r>
                  <a:rPr lang="en-US" altLang="en-US" sz="1400" dirty="0"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appropriate antimicrobial regimens</a:t>
                </a:r>
              </a:p>
            </p:txBody>
          </p:sp>
          <p:sp>
            <p:nvSpPr>
              <p:cNvPr id="22" name="Up Arrow 66">
                <a:extLst>
                  <a:ext uri="{FF2B5EF4-FFF2-40B4-BE49-F238E27FC236}">
                    <a16:creationId xmlns:a16="http://schemas.microsoft.com/office/drawing/2014/main" id="{B67F6EBA-1429-ABDC-E3B2-BA72491B9564}"/>
                  </a:ext>
                </a:extLst>
              </p:cNvPr>
              <p:cNvSpPr/>
              <p:nvPr/>
            </p:nvSpPr>
            <p:spPr>
              <a:xfrm>
                <a:off x="11237971" y="3720730"/>
                <a:ext cx="406800" cy="317912"/>
              </a:xfrm>
              <a:prstGeom prst="upArrow">
                <a:avLst/>
              </a:prstGeom>
              <a:solidFill>
                <a:srgbClr val="DB3142"/>
              </a:solidFill>
              <a:ln>
                <a:solidFill>
                  <a:srgbClr val="DB314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Verdana" panose="020B0604030504040204" pitchFamily="34" charset="0"/>
                  <a:ea typeface="Verdana" panose="020B0604030504040204" pitchFamily="34" charset="0"/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A9D13B24-0CF5-3B1E-2AB3-51DCB6EF939A}"/>
                  </a:ext>
                </a:extLst>
              </p:cNvPr>
              <p:cNvSpPr/>
              <p:nvPr/>
            </p:nvSpPr>
            <p:spPr>
              <a:xfrm>
                <a:off x="10287972" y="3687034"/>
                <a:ext cx="1120820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en-US" sz="2400" b="1" dirty="0">
                    <a:latin typeface="Verdana Pro Semibold" panose="020B07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15% </a:t>
                </a:r>
                <a:endParaRPr lang="en-US" sz="2400" b="1" dirty="0">
                  <a:latin typeface="Verdana Pro Semibold" panose="020B0704030504040204" pitchFamily="34" charset="0"/>
                </a:endParaRP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10157109" y="5036985"/>
              <a:ext cx="1508680" cy="875132"/>
              <a:chOff x="10253066" y="3828496"/>
              <a:chExt cx="1508680" cy="875132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EA6E6A3B-8EB1-DDBF-B208-15E986A7219D}"/>
                  </a:ext>
                </a:extLst>
              </p:cNvPr>
              <p:cNvSpPr/>
              <p:nvPr/>
            </p:nvSpPr>
            <p:spPr>
              <a:xfrm>
                <a:off x="10271729" y="4223497"/>
                <a:ext cx="1490017" cy="48013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90000"/>
                  </a:lnSpc>
                </a:pPr>
                <a:r>
                  <a:rPr lang="en-US" altLang="en-US" sz="1400" dirty="0"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in optimal regimens</a:t>
                </a:r>
              </a:p>
            </p:txBody>
          </p:sp>
          <p:sp>
            <p:nvSpPr>
              <p:cNvPr id="37" name="Up Arrow 66">
                <a:extLst>
                  <a:ext uri="{FF2B5EF4-FFF2-40B4-BE49-F238E27FC236}">
                    <a16:creationId xmlns:a16="http://schemas.microsoft.com/office/drawing/2014/main" id="{B67F6EBA-1429-ABDC-E3B2-BA72491B9564}"/>
                  </a:ext>
                </a:extLst>
              </p:cNvPr>
              <p:cNvSpPr/>
              <p:nvPr/>
            </p:nvSpPr>
            <p:spPr>
              <a:xfrm>
                <a:off x="11203065" y="3857939"/>
                <a:ext cx="406800" cy="317912"/>
              </a:xfrm>
              <a:prstGeom prst="upArrow">
                <a:avLst/>
              </a:prstGeom>
              <a:solidFill>
                <a:srgbClr val="DB3142"/>
              </a:solidFill>
              <a:ln>
                <a:solidFill>
                  <a:srgbClr val="DB314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Verdana" panose="020B0604030504040204" pitchFamily="34" charset="0"/>
                  <a:ea typeface="Verdana" panose="020B0604030504040204" pitchFamily="34" charset="0"/>
                </a:endParaRP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A9D13B24-0CF5-3B1E-2AB3-51DCB6EF939A}"/>
                  </a:ext>
                </a:extLst>
              </p:cNvPr>
              <p:cNvSpPr/>
              <p:nvPr/>
            </p:nvSpPr>
            <p:spPr>
              <a:xfrm>
                <a:off x="10253066" y="3828496"/>
                <a:ext cx="1120820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en-US" sz="2400" b="1" dirty="0">
                    <a:latin typeface="Verdana Pro Semibold" panose="020B07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18% </a:t>
                </a:r>
                <a:endParaRPr lang="en-US" sz="2400" b="1" dirty="0">
                  <a:latin typeface="Verdana Pro Semibold" panose="020B0704030504040204" pitchFamily="34" charset="0"/>
                </a:endParaRPr>
              </a:p>
            </p:txBody>
          </p:sp>
        </p:grpSp>
      </p:grpSp>
      <p:sp>
        <p:nvSpPr>
          <p:cNvPr id="41" name="TextBox 1"/>
          <p:cNvSpPr txBox="1"/>
          <p:nvPr/>
        </p:nvSpPr>
        <p:spPr>
          <a:xfrm>
            <a:off x="7945217" y="4271897"/>
            <a:ext cx="1718441" cy="29151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Verdana" panose="020B0604030504040204" pitchFamily="34" charset="0"/>
                <a:ea typeface="Verdana" panose="020B0604030504040204" pitchFamily="34" charset="0"/>
              </a:rPr>
              <a:t>Appropriate</a:t>
            </a:r>
            <a:endParaRPr lang="en-US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pic>
        <p:nvPicPr>
          <p:cNvPr id="12" name="Graphic 11" descr="Users outline">
            <a:extLst>
              <a:ext uri="{FF2B5EF4-FFF2-40B4-BE49-F238E27FC236}">
                <a16:creationId xmlns:a16="http://schemas.microsoft.com/office/drawing/2014/main" id="{E0EF66DF-8047-2671-D6F3-99805B4433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=""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960194" y="1830750"/>
            <a:ext cx="1253428" cy="1253428"/>
          </a:xfrm>
          <a:prstGeom prst="rect">
            <a:avLst/>
          </a:prstGeom>
        </p:spPr>
      </p:pic>
      <p:pic>
        <p:nvPicPr>
          <p:cNvPr id="18" name="Graphic 17" descr="Users outline">
            <a:extLst>
              <a:ext uri="{FF2B5EF4-FFF2-40B4-BE49-F238E27FC236}">
                <a16:creationId xmlns:a16="http://schemas.microsoft.com/office/drawing/2014/main" id="{4395D5DF-3D35-6EE6-82AB-8AE2DE31989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=""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487893" y="1842769"/>
            <a:ext cx="1253428" cy="1253428"/>
          </a:xfrm>
          <a:prstGeom prst="rect">
            <a:avLst/>
          </a:prstGeom>
        </p:spPr>
      </p:pic>
      <p:pic>
        <p:nvPicPr>
          <p:cNvPr id="26" name="Graphic 25" descr="Document outline">
            <a:extLst>
              <a:ext uri="{FF2B5EF4-FFF2-40B4-BE49-F238E27FC236}">
                <a16:creationId xmlns:a16="http://schemas.microsoft.com/office/drawing/2014/main" id="{F4D45CFE-E90F-1B54-A0FC-9A4698D8AAC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=""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63416" y="1959613"/>
            <a:ext cx="1206373" cy="1206373"/>
          </a:xfrm>
          <a:prstGeom prst="rect">
            <a:avLst/>
          </a:prstGeom>
        </p:spPr>
      </p:pic>
      <p:pic>
        <p:nvPicPr>
          <p:cNvPr id="39" name="Graphic 38" descr="Teacher outline">
            <a:extLst>
              <a:ext uri="{FF2B5EF4-FFF2-40B4-BE49-F238E27FC236}">
                <a16:creationId xmlns:a16="http://schemas.microsoft.com/office/drawing/2014/main" id="{D6B5B09E-6172-6D69-15D0-B0116DBA678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=""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527680" y="3263952"/>
            <a:ext cx="1123084" cy="1123084"/>
          </a:xfrm>
          <a:prstGeom prst="rect">
            <a:avLst/>
          </a:prstGeom>
        </p:spPr>
      </p:pic>
      <p:pic>
        <p:nvPicPr>
          <p:cNvPr id="42" name="Graphic 41" descr="Medicine outline">
            <a:extLst>
              <a:ext uri="{FF2B5EF4-FFF2-40B4-BE49-F238E27FC236}">
                <a16:creationId xmlns:a16="http://schemas.microsoft.com/office/drawing/2014/main" id="{61B25A1C-206D-DFF7-B8F8-E03C15C02C9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=""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640374" y="4489257"/>
            <a:ext cx="1196421" cy="1196421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0416427" y="3521701"/>
            <a:ext cx="1436267" cy="131355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10421736" y="4915524"/>
            <a:ext cx="1436267" cy="8853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3806835" y="5882525"/>
            <a:ext cx="57227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*National Antimicrobial Prescribing Survey</a:t>
            </a:r>
            <a:endParaRPr lang="en-US" sz="1400" dirty="0">
              <a:solidFill>
                <a:schemeClr val="bg1"/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5600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65</TotalTime>
  <Words>82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Verdana</vt:lpstr>
      <vt:lpstr>Verdana Pro Semibold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ta Sahara</dc:creator>
  <cp:lastModifiedBy>Adenkar, Gargi</cp:lastModifiedBy>
  <cp:revision>42</cp:revision>
  <dcterms:created xsi:type="dcterms:W3CDTF">2019-09-04T17:40:20Z</dcterms:created>
  <dcterms:modified xsi:type="dcterms:W3CDTF">2025-02-26T21:58:53Z</dcterms:modified>
</cp:coreProperties>
</file>